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906000" type="A4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1" d="100"/>
          <a:sy n="91" d="100"/>
        </p:scale>
        <p:origin x="-1218" y="238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92B64C-92A6-4443-B744-C4E22BEFE740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0FB836-0BA7-452A-9E59-68529ED7D3CE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2969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1546" y="144016"/>
            <a:ext cx="4534908" cy="891344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52078" y="9057455"/>
            <a:ext cx="49145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. 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4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thocyanin biosynthesis pathway as retrieved from KEGG databas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enzyme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anthocyanidin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3-O-glucosyltransferase (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E.C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number 2.4.1.115),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s highlighted in red.</a:t>
            </a:r>
            <a:endParaRPr lang="el-G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3357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4.PPTX</DocumentId>
    <DocumentType xmlns="370fed10-a368-469c-a864-2e77a9536334">Presentation</DocumentType>
    <TitleName xmlns="370fed10-a368-469c-a864-2e77a9536334">Presentation 4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36912371-B5C9-4D2E-A3D4-926C38DC2524}"/>
</file>

<file path=customXml/itemProps2.xml><?xml version="1.0" encoding="utf-8"?>
<ds:datastoreItem xmlns:ds="http://schemas.openxmlformats.org/officeDocument/2006/customXml" ds:itemID="{D2E99938-DAF5-43E7-B2F5-C6FD3728AD08}"/>
</file>

<file path=customXml/itemProps3.xml><?xml version="1.0" encoding="utf-8"?>
<ds:datastoreItem xmlns:ds="http://schemas.openxmlformats.org/officeDocument/2006/customXml" ds:itemID="{6AF2A0D2-E00E-4B5F-8466-F46E33935201}"/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29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pasia</dc:creator>
  <cp:lastModifiedBy>Koudounas</cp:lastModifiedBy>
  <cp:revision>18</cp:revision>
  <dcterms:created xsi:type="dcterms:W3CDTF">2013-04-30T09:15:21Z</dcterms:created>
  <dcterms:modified xsi:type="dcterms:W3CDTF">2015-07-06T15:03:02Z</dcterms:modified>
</cp:coreProperties>
</file>